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8" r:id="rId2"/>
    <p:sldId id="257" r:id="rId3"/>
    <p:sldId id="258" r:id="rId4"/>
    <p:sldId id="259" r:id="rId5"/>
    <p:sldId id="264" r:id="rId6"/>
    <p:sldId id="265" r:id="rId7"/>
    <p:sldId id="266" r:id="rId8"/>
    <p:sldId id="267" r:id="rId9"/>
    <p:sldId id="268" r:id="rId10"/>
    <p:sldId id="269" r:id="rId11"/>
    <p:sldId id="313" r:id="rId12"/>
    <p:sldId id="314" r:id="rId13"/>
    <p:sldId id="315" r:id="rId14"/>
    <p:sldId id="316" r:id="rId15"/>
    <p:sldId id="317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90" r:id="rId35"/>
    <p:sldId id="291" r:id="rId3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presProps" Target="presProps.xml"/><Relationship Id="rId40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F40FF-0F16-415C-B456-02A5FE7C5E4E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D3C2-6B23-41D9-A68C-663370972A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56049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F40FF-0F16-415C-B456-02A5FE7C5E4E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D3C2-6B23-41D9-A68C-663370972A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9361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F40FF-0F16-415C-B456-02A5FE7C5E4E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D3C2-6B23-41D9-A68C-663370972A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9681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F40FF-0F16-415C-B456-02A5FE7C5E4E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D3C2-6B23-41D9-A68C-663370972A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1070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F40FF-0F16-415C-B456-02A5FE7C5E4E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D3C2-6B23-41D9-A68C-663370972A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47072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F40FF-0F16-415C-B456-02A5FE7C5E4E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D3C2-6B23-41D9-A68C-663370972A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2411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F40FF-0F16-415C-B456-02A5FE7C5E4E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D3C2-6B23-41D9-A68C-663370972A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23621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F40FF-0F16-415C-B456-02A5FE7C5E4E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D3C2-6B23-41D9-A68C-663370972A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7895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F40FF-0F16-415C-B456-02A5FE7C5E4E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D3C2-6B23-41D9-A68C-663370972A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66019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F40FF-0F16-415C-B456-02A5FE7C5E4E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D3C2-6B23-41D9-A68C-663370972A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678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F40FF-0F16-415C-B456-02A5FE7C5E4E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D3C2-6B23-41D9-A68C-663370972A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8560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CF40FF-0F16-415C-B456-02A5FE7C5E4E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47D3C2-6B23-41D9-A68C-663370972A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9918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1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1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1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00890" y="933790"/>
            <a:ext cx="10990217" cy="1332820"/>
          </a:xfrm>
        </p:spPr>
        <p:txBody>
          <a:bodyPr>
            <a:normAutofit fontScale="90000"/>
          </a:bodyPr>
          <a:lstStyle/>
          <a:p>
            <a:pPr algn="l"/>
            <a:br>
              <a:rPr lang="de-DE" sz="4900"/>
            </a:br>
            <a:r>
              <a:rPr lang="en-GB" sz="4900"/>
              <a:t>Assessing outlier probabilities in transcriptomics data when evaluating a classifier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600889" y="4316141"/>
            <a:ext cx="10990217" cy="1655762"/>
          </a:xfrm>
        </p:spPr>
        <p:txBody>
          <a:bodyPr>
            <a:normAutofit/>
          </a:bodyPr>
          <a:lstStyle/>
          <a:p>
            <a:pPr algn="l"/>
            <a:r>
              <a:rPr lang="de-DE" sz="2000"/>
              <a:t>Magdalena Kircher </a:t>
            </a:r>
            <a:r>
              <a:rPr lang="de-DE" sz="2000" baseline="30000"/>
              <a:t>1</a:t>
            </a:r>
            <a:r>
              <a:rPr lang="de-DE" sz="2000"/>
              <a:t> , Josefin Säurich </a:t>
            </a:r>
            <a:r>
              <a:rPr lang="de-DE" sz="2000" baseline="30000"/>
              <a:t>1</a:t>
            </a:r>
            <a:r>
              <a:rPr lang="de-DE" sz="2000"/>
              <a:t>, Michael Selle</a:t>
            </a:r>
            <a:r>
              <a:rPr lang="de-DE" sz="2000" baseline="30000"/>
              <a:t>1</a:t>
            </a:r>
            <a:r>
              <a:rPr lang="de-DE" sz="2000"/>
              <a:t>, and Klaus Jung </a:t>
            </a:r>
            <a:r>
              <a:rPr lang="de-DE" sz="2000" baseline="30000"/>
              <a:t>1,*</a:t>
            </a:r>
          </a:p>
          <a:p>
            <a:pPr algn="l"/>
            <a:r>
              <a:rPr lang="en-GB" sz="2000" baseline="30000"/>
              <a:t>1</a:t>
            </a:r>
            <a:r>
              <a:rPr lang="en-GB" sz="2000"/>
              <a:t> Institute for Animal Breeding and Genetics, University of Veterinary Medicine Hannover</a:t>
            </a:r>
          </a:p>
          <a:p>
            <a:pPr algn="l"/>
            <a:r>
              <a:rPr lang="en-GB" sz="2000" baseline="30000"/>
              <a:t>*</a:t>
            </a:r>
            <a:r>
              <a:rPr lang="en-GB" sz="2000"/>
              <a:t> Correspondence: klaus.jung@tiho-hannover.de; Tel.:+49 511 953-8878</a:t>
            </a:r>
          </a:p>
        </p:txBody>
      </p:sp>
      <p:sp>
        <p:nvSpPr>
          <p:cNvPr id="4" name="Rechteck 3"/>
          <p:cNvSpPr/>
          <p:nvPr/>
        </p:nvSpPr>
        <p:spPr>
          <a:xfrm>
            <a:off x="2235485" y="2937432"/>
            <a:ext cx="7721024" cy="70788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4000">
                <a:latin typeface="+mj-lt"/>
              </a:rPr>
              <a:t>- </a:t>
            </a:r>
            <a:r>
              <a:rPr lang="de-DE" sz="4000">
                <a:latin typeface="+mj-lt"/>
              </a:rPr>
              <a:t>Supplementary figures and tables - </a:t>
            </a:r>
            <a:endParaRPr lang="en-GB" sz="400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8514701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9: Boxplots of positive and negative predictive values for simulation data using LDA in a two-study-group scenario</a:t>
            </a:r>
            <a:endParaRPr lang="en-GB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4075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582743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4957" y="1579418"/>
            <a:ext cx="10733239" cy="5148881"/>
          </a:xfrm>
          <a:prstGeom prst="rect">
            <a:avLst/>
          </a:prstGeom>
        </p:spPr>
      </p:pic>
      <p:sp>
        <p:nvSpPr>
          <p:cNvPr id="4" name="Textfeld 3"/>
          <p:cNvSpPr txBox="1"/>
          <p:nvPr/>
        </p:nvSpPr>
        <p:spPr>
          <a:xfrm>
            <a:off x="432000" y="360000"/>
            <a:ext cx="11160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10: Comparison of outlier detection methods within bootstrap approach – Boxplots </a:t>
            </a:r>
            <a:r>
              <a:rPr lang="en-GB" sz="2400" dirty="0"/>
              <a:t>of accuracies and Brier scores </a:t>
            </a:r>
            <a:r>
              <a:rPr lang="de-DE" sz="2400" dirty="0"/>
              <a:t>using SVM in a two-study-group scenario</a:t>
            </a:r>
            <a:endParaRPr lang="en-GB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47779" y="1254544"/>
            <a:ext cx="4728441" cy="3540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261518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11: Comparison of outlier detection methods within bootstrap approach – Boxplots </a:t>
            </a:r>
            <a:r>
              <a:rPr lang="en-GB" sz="2400" dirty="0"/>
              <a:t>of </a:t>
            </a:r>
            <a:r>
              <a:rPr lang="de-DE" sz="2400" dirty="0"/>
              <a:t>sensitivities and specificities using SVM in a two-study-group scenario</a:t>
            </a:r>
            <a:endParaRPr lang="en-GB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47779" y="1254544"/>
            <a:ext cx="4728441" cy="354062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1128" y="1608606"/>
            <a:ext cx="10829412" cy="51045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643794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2086" y="1534715"/>
            <a:ext cx="10845261" cy="5217067"/>
          </a:xfrm>
          <a:prstGeom prst="rect">
            <a:avLst/>
          </a:prstGeom>
        </p:spPr>
      </p:pic>
      <p:sp>
        <p:nvSpPr>
          <p:cNvPr id="4" name="Textfeld 3"/>
          <p:cNvSpPr txBox="1"/>
          <p:nvPr/>
        </p:nvSpPr>
        <p:spPr>
          <a:xfrm>
            <a:off x="432000" y="360000"/>
            <a:ext cx="11160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12: Comparison of outlier detection methods within bootstrap approach – Boxplots </a:t>
            </a:r>
            <a:r>
              <a:rPr lang="en-GB" sz="2400" dirty="0"/>
              <a:t>of positive and negative predictive values </a:t>
            </a:r>
            <a:r>
              <a:rPr lang="de-DE" sz="2400" dirty="0"/>
              <a:t>using SVM in a two-study-group scenario</a:t>
            </a:r>
            <a:endParaRPr lang="en-GB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47779" y="1254544"/>
            <a:ext cx="4728441" cy="3540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792749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13: Boxplots of accuracies and Brier scores for simulation data using SVM in a four-study-group scenario</a:t>
            </a:r>
            <a:endParaRPr lang="en-GB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6292" y="1190997"/>
            <a:ext cx="10678976" cy="55241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121800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14: Comparison of outlier detection methods within bootstrap approach – Boxplots of accuracies and Brier scores for simulation data using SVM in a four-study-group scenario</a:t>
            </a:r>
            <a:endParaRPr lang="en-GB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2000" y="1190997"/>
            <a:ext cx="10737687" cy="55315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094279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0742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15: Mean accuracies and Brier scores (+/- 1 standard error) for SARS-CoV-2 data using SVM</a:t>
            </a:r>
            <a:endParaRPr lang="en-GB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439857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507629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16: Mean sensitivities and specificities (+/- 1 standard error) for SARS-CoV-2 data using SVM</a:t>
            </a:r>
            <a:endParaRPr lang="en-GB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6725" y="1116000"/>
            <a:ext cx="11418248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75219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17: Mean positive and negative predictive values (+/- 1 standard error) for SARS-CoV-2 data using SVM</a:t>
            </a:r>
            <a:endParaRPr lang="en-GB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447227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324143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18: Mean accuracies and Brier scores (+/- 1 standard error) for SARS-CoV-2 data using RF</a:t>
            </a:r>
            <a:endParaRPr lang="en-GB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44955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66639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1: Boxplots of accuracies and Brier scores for simulation data using SVM in a two-study-group scenario</a:t>
            </a:r>
            <a:endParaRPr lang="en-GB" sz="2400" dirty="0"/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408586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246531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19: Mean sensitivities and specificities (+/- 1 standard error) for SARS-CoV-2 data using RF</a:t>
            </a:r>
            <a:endParaRPr lang="en-GB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6725" y="1116000"/>
            <a:ext cx="11418248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00051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20: Mean positive and negative predictive values (+/- 1 standard error) for SARS-CoV-2 data using RF</a:t>
            </a:r>
            <a:endParaRPr lang="en-GB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338078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069558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21: Mean accuracies and Brier scores (+/- 1 standard error) for SARS-CoV-2 data using LDA</a:t>
            </a:r>
            <a:endParaRPr lang="en-GB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430161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3553471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22: Mean sensitivities and specificities (+/- 1 standard error) for SARS-CoV-2 data using LDA</a:t>
            </a:r>
            <a:endParaRPr lang="en-GB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6725" y="1116000"/>
            <a:ext cx="1143871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4968420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23: Mean negative and positive predictive values (+/- 1 standard error) for SARS-CoV-2 data using LDA</a:t>
            </a:r>
            <a:endParaRPr lang="en-GB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468942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803531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0742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24: Mean accuracies and Brier scores (+/- 1 standard error) for WNV data using SVM</a:t>
            </a:r>
            <a:endParaRPr lang="en-GB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388214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024723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25: Mean sensitivities and specificities (+/- 1 standard error) for WNV data using SVM</a:t>
            </a:r>
            <a:endParaRPr lang="en-GB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4075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1354374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26: Mean positive and negative predictive values (+/- 1 standard error) for WNV data using SVM</a:t>
            </a:r>
            <a:endParaRPr lang="en-GB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408586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7254044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27: Mean accuracies and Brier scores (+/- 1 standard error) for WNV data using RF</a:t>
            </a:r>
            <a:endParaRPr lang="en-GB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318861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0982391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28: Mean sensitivities and specificities (+/- 1 standard error) for WNV data using RF</a:t>
            </a:r>
            <a:endParaRPr lang="en-GB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387165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96640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2: Boxplots of sensitivities and specificities for simulation data using SVM in a two-study-group scenario</a:t>
            </a:r>
            <a:endParaRPr lang="en-GB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44955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1161498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29: Mean positive and negative predictive values (+/- 1 standard error) for WNV data using RF</a:t>
            </a:r>
            <a:endParaRPr lang="en-GB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6725" y="1116000"/>
            <a:ext cx="11397857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2575645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30: Mean accuracies and Brier scores (+/- 1 standard error) for WNV data using LDA</a:t>
            </a:r>
            <a:endParaRPr lang="en-GB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4075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0197224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31: Mean sensitivities and specificities (+/- 1 standard error) for WNV data using LDA</a:t>
            </a:r>
            <a:endParaRPr lang="en-GB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430161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3372677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32: Mean negative and positive predictive values (+/- 1 standard error) for WNV data using LDA</a:t>
            </a:r>
            <a:endParaRPr lang="en-GB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419355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4478140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Table S1: 30 samples most frequently detected as outliers in the SARS-CoV-2 data set during bootstrap analysis using PCA-Grid</a:t>
            </a:r>
            <a:endParaRPr lang="en-GB" sz="2400" dirty="0"/>
          </a:p>
        </p:txBody>
      </p:sp>
      <p:graphicFrame>
        <p:nvGraphicFramePr>
          <p:cNvPr id="8" name="Tabel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3382215"/>
              </p:ext>
            </p:extLst>
          </p:nvPr>
        </p:nvGraphicFramePr>
        <p:xfrm>
          <a:off x="548409" y="1391370"/>
          <a:ext cx="4444999" cy="3238500"/>
        </p:xfrm>
        <a:graphic>
          <a:graphicData uri="http://schemas.openxmlformats.org/drawingml/2006/table">
            <a:tbl>
              <a:tblPr/>
              <a:tblGrid>
                <a:gridCol w="799529">
                  <a:extLst>
                    <a:ext uri="{9D8B030D-6E8A-4147-A177-3AD203B41FA5}">
                      <a16:colId xmlns:a16="http://schemas.microsoft.com/office/drawing/2014/main" val="326585916"/>
                    </a:ext>
                  </a:extLst>
                </a:gridCol>
                <a:gridCol w="901056">
                  <a:extLst>
                    <a:ext uri="{9D8B030D-6E8A-4147-A177-3AD203B41FA5}">
                      <a16:colId xmlns:a16="http://schemas.microsoft.com/office/drawing/2014/main" val="3425193481"/>
                    </a:ext>
                  </a:extLst>
                </a:gridCol>
                <a:gridCol w="761456">
                  <a:extLst>
                    <a:ext uri="{9D8B030D-6E8A-4147-A177-3AD203B41FA5}">
                      <a16:colId xmlns:a16="http://schemas.microsoft.com/office/drawing/2014/main" val="485032848"/>
                    </a:ext>
                  </a:extLst>
                </a:gridCol>
                <a:gridCol w="713865">
                  <a:extLst>
                    <a:ext uri="{9D8B030D-6E8A-4147-A177-3AD203B41FA5}">
                      <a16:colId xmlns:a16="http://schemas.microsoft.com/office/drawing/2014/main" val="79247458"/>
                    </a:ext>
                  </a:extLst>
                </a:gridCol>
                <a:gridCol w="748765">
                  <a:extLst>
                    <a:ext uri="{9D8B030D-6E8A-4147-A177-3AD203B41FA5}">
                      <a16:colId xmlns:a16="http://schemas.microsoft.com/office/drawing/2014/main" val="371157514"/>
                    </a:ext>
                  </a:extLst>
                </a:gridCol>
                <a:gridCol w="520328">
                  <a:extLst>
                    <a:ext uri="{9D8B030D-6E8A-4147-A177-3AD203B41FA5}">
                      <a16:colId xmlns:a16="http://schemas.microsoft.com/office/drawing/2014/main" val="3962756012"/>
                    </a:ext>
                  </a:extLst>
                </a:gridCol>
              </a:tblGrid>
              <a:tr h="38100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mple I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curence in </a:t>
                      </a:r>
                      <a:b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ootstrappin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tected as </a:t>
                      </a:r>
                      <a:b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utlie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utlier </a:t>
                      </a:r>
                      <a:b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babilit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dence </a:t>
                      </a:r>
                      <a:b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va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634223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8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96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313099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8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95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585132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87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95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381752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8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95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348727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8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95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86919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9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95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908507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94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96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456178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30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96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5502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30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95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884387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31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95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110977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31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93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294668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92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92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342986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85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90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553059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8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90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7665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89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89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3676800"/>
                  </a:ext>
                </a:extLst>
              </a:tr>
            </a:tbl>
          </a:graphicData>
        </a:graphic>
      </p:graphicFrame>
      <p:graphicFrame>
        <p:nvGraphicFramePr>
          <p:cNvPr id="9" name="Tabel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1420915"/>
              </p:ext>
            </p:extLst>
          </p:nvPr>
        </p:nvGraphicFramePr>
        <p:xfrm>
          <a:off x="6086815" y="1386202"/>
          <a:ext cx="4444999" cy="3238500"/>
        </p:xfrm>
        <a:graphic>
          <a:graphicData uri="http://schemas.openxmlformats.org/drawingml/2006/table">
            <a:tbl>
              <a:tblPr/>
              <a:tblGrid>
                <a:gridCol w="799529">
                  <a:extLst>
                    <a:ext uri="{9D8B030D-6E8A-4147-A177-3AD203B41FA5}">
                      <a16:colId xmlns:a16="http://schemas.microsoft.com/office/drawing/2014/main" val="2586321023"/>
                    </a:ext>
                  </a:extLst>
                </a:gridCol>
                <a:gridCol w="901056">
                  <a:extLst>
                    <a:ext uri="{9D8B030D-6E8A-4147-A177-3AD203B41FA5}">
                      <a16:colId xmlns:a16="http://schemas.microsoft.com/office/drawing/2014/main" val="4202590019"/>
                    </a:ext>
                  </a:extLst>
                </a:gridCol>
                <a:gridCol w="761456">
                  <a:extLst>
                    <a:ext uri="{9D8B030D-6E8A-4147-A177-3AD203B41FA5}">
                      <a16:colId xmlns:a16="http://schemas.microsoft.com/office/drawing/2014/main" val="886521947"/>
                    </a:ext>
                  </a:extLst>
                </a:gridCol>
                <a:gridCol w="713865">
                  <a:extLst>
                    <a:ext uri="{9D8B030D-6E8A-4147-A177-3AD203B41FA5}">
                      <a16:colId xmlns:a16="http://schemas.microsoft.com/office/drawing/2014/main" val="2297720241"/>
                    </a:ext>
                  </a:extLst>
                </a:gridCol>
                <a:gridCol w="748765">
                  <a:extLst>
                    <a:ext uri="{9D8B030D-6E8A-4147-A177-3AD203B41FA5}">
                      <a16:colId xmlns:a16="http://schemas.microsoft.com/office/drawing/2014/main" val="2052980700"/>
                    </a:ext>
                  </a:extLst>
                </a:gridCol>
                <a:gridCol w="520328">
                  <a:extLst>
                    <a:ext uri="{9D8B030D-6E8A-4147-A177-3AD203B41FA5}">
                      <a16:colId xmlns:a16="http://schemas.microsoft.com/office/drawing/2014/main" val="2926323387"/>
                    </a:ext>
                  </a:extLst>
                </a:gridCol>
              </a:tblGrid>
              <a:tr h="38100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mple I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curence in </a:t>
                      </a:r>
                      <a:b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ootstrappin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tected as </a:t>
                      </a:r>
                      <a:b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utlie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utlier </a:t>
                      </a:r>
                      <a:b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babilit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dence </a:t>
                      </a:r>
                      <a:b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va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930795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8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86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28213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9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86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486098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308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84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220537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8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82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493958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91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81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824017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308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78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496125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31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74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517504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88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73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684956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99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61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049298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97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60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286647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9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58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352026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31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55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167703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30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54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955369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307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46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506846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497287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43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251915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72498910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Table S2: 20 samples most frequently detected as outliers in the WNV data set during bootstrap analysis using PCA-Grid</a:t>
            </a:r>
            <a:endParaRPr lang="en-GB" sz="2400" dirty="0"/>
          </a:p>
        </p:txBody>
      </p:sp>
      <p:graphicFrame>
        <p:nvGraphicFramePr>
          <p:cNvPr id="3" name="Tabel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3450975"/>
              </p:ext>
            </p:extLst>
          </p:nvPr>
        </p:nvGraphicFramePr>
        <p:xfrm>
          <a:off x="548409" y="1393954"/>
          <a:ext cx="4445000" cy="4200525"/>
        </p:xfrm>
        <a:graphic>
          <a:graphicData uri="http://schemas.openxmlformats.org/drawingml/2006/table">
            <a:tbl>
              <a:tblPr/>
              <a:tblGrid>
                <a:gridCol w="798959">
                  <a:extLst>
                    <a:ext uri="{9D8B030D-6E8A-4147-A177-3AD203B41FA5}">
                      <a16:colId xmlns:a16="http://schemas.microsoft.com/office/drawing/2014/main" val="1666873033"/>
                    </a:ext>
                  </a:extLst>
                </a:gridCol>
                <a:gridCol w="903584">
                  <a:extLst>
                    <a:ext uri="{9D8B030D-6E8A-4147-A177-3AD203B41FA5}">
                      <a16:colId xmlns:a16="http://schemas.microsoft.com/office/drawing/2014/main" val="1032066967"/>
                    </a:ext>
                  </a:extLst>
                </a:gridCol>
                <a:gridCol w="760913">
                  <a:extLst>
                    <a:ext uri="{9D8B030D-6E8A-4147-A177-3AD203B41FA5}">
                      <a16:colId xmlns:a16="http://schemas.microsoft.com/office/drawing/2014/main" val="2549259690"/>
                    </a:ext>
                  </a:extLst>
                </a:gridCol>
                <a:gridCol w="713356">
                  <a:extLst>
                    <a:ext uri="{9D8B030D-6E8A-4147-A177-3AD203B41FA5}">
                      <a16:colId xmlns:a16="http://schemas.microsoft.com/office/drawing/2014/main" val="1283558882"/>
                    </a:ext>
                  </a:extLst>
                </a:gridCol>
                <a:gridCol w="748231">
                  <a:extLst>
                    <a:ext uri="{9D8B030D-6E8A-4147-A177-3AD203B41FA5}">
                      <a16:colId xmlns:a16="http://schemas.microsoft.com/office/drawing/2014/main" val="279504565"/>
                    </a:ext>
                  </a:extLst>
                </a:gridCol>
                <a:gridCol w="519957">
                  <a:extLst>
                    <a:ext uri="{9D8B030D-6E8A-4147-A177-3AD203B41FA5}">
                      <a16:colId xmlns:a16="http://schemas.microsoft.com/office/drawing/2014/main" val="2425546134"/>
                    </a:ext>
                  </a:extLst>
                </a:gridCol>
              </a:tblGrid>
              <a:tr h="390525"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mple I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curence in </a:t>
                      </a:r>
                      <a:b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ootstrappin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tected as </a:t>
                      </a:r>
                      <a:b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utlie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utlier </a:t>
                      </a:r>
                      <a:b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babilit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idence </a:t>
                      </a:r>
                      <a:b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va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531681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13395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95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860989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0580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93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568908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0580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47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178767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1339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42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460092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05809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40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145918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13394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29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7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22787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1339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25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440656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0580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16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894834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0580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16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052564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1339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12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830173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05808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9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201484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13395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8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181822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0580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7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673996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0580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7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279799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1339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5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014453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05808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4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607313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0580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3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00667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1339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3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20567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1339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2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824905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M105807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2,1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33101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521425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3: Boxplots of positive and negative predictive values for simulation data using SVM in a two-study-group scenario</a:t>
            </a:r>
            <a:endParaRPr lang="en-GB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468942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65020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4: Boxplots of accuracies and Brier scores for simulation data using RF in a two-study-group scenario</a:t>
            </a:r>
            <a:endParaRPr lang="en-GB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389266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79966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5: Boxplots of sensitivities and specificities for simulation data using RF in a two-study-group scenario</a:t>
            </a:r>
            <a:endParaRPr lang="en-GB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453069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97635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6: Boxplots of positive and negative predictive values for simulation data using RF in a two-study-group scenario</a:t>
            </a:r>
            <a:endParaRPr lang="en-GB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470145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02579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7: Boxplots of accuracies and Brier scores for simulation data using LDA in a two-study-group scenario</a:t>
            </a:r>
            <a:endParaRPr lang="en-GB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437566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91657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32000" y="360000"/>
            <a:ext cx="111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Supplementary Figure S8: Boxplots of sensitivities and specificities for simulation data using LDA in a two-study-group scenario</a:t>
            </a:r>
            <a:endParaRPr lang="en-GB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000" y="1116000"/>
            <a:ext cx="114075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938617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216</Words>
  <Application>Microsoft Office PowerPoint</Application>
  <PresentationFormat>Widescreen</PresentationFormat>
  <Paragraphs>357</Paragraphs>
  <Slides>3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5</vt:i4>
      </vt:variant>
    </vt:vector>
  </HeadingPairs>
  <TitlesOfParts>
    <vt:vector size="39" baseType="lpstr">
      <vt:lpstr>Arial</vt:lpstr>
      <vt:lpstr>Calibri</vt:lpstr>
      <vt:lpstr>Calibri Light</vt:lpstr>
      <vt:lpstr>Office</vt:lpstr>
      <vt:lpstr> Assessing outlier probabilities in transcriptomics data when evaluating a classifier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ircher, Magdalena</dc:creator>
  <cp:lastModifiedBy>MDPI</cp:lastModifiedBy>
  <cp:revision>38</cp:revision>
  <dcterms:created xsi:type="dcterms:W3CDTF">2022-11-28T10:55:50Z</dcterms:created>
  <dcterms:modified xsi:type="dcterms:W3CDTF">2023-02-01T07:29:10Z</dcterms:modified>
</cp:coreProperties>
</file>